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54"/>
    <p:restoredTop sz="94595"/>
  </p:normalViewPr>
  <p:slideViewPr>
    <p:cSldViewPr snapToGrid="0" snapToObjects="1">
      <p:cViewPr varScale="1">
        <p:scale>
          <a:sx n="96" d="100"/>
          <a:sy n="96" d="100"/>
        </p:scale>
        <p:origin x="17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ters, Christopher" userId="62418469-15cb-4bfd-8077-e64d9edbe607" providerId="ADAL" clId="{D0E6B1A4-B86E-48C4-BA7A-F770D28330C7}"/>
    <pc:docChg chg="delSld">
      <pc:chgData name="Waters, Christopher" userId="62418469-15cb-4bfd-8077-e64d9edbe607" providerId="ADAL" clId="{D0E6B1A4-B86E-48C4-BA7A-F770D28330C7}" dt="2020-10-06T14:50:15.252" v="8" actId="47"/>
      <pc:docMkLst>
        <pc:docMk/>
      </pc:docMkLst>
      <pc:sldChg chg="del">
        <pc:chgData name="Waters, Christopher" userId="62418469-15cb-4bfd-8077-e64d9edbe607" providerId="ADAL" clId="{D0E6B1A4-B86E-48C4-BA7A-F770D28330C7}" dt="2020-10-06T14:50:14.832" v="7" actId="47"/>
        <pc:sldMkLst>
          <pc:docMk/>
          <pc:sldMk cId="1851293959" sldId="262"/>
        </pc:sldMkLst>
      </pc:sldChg>
      <pc:sldChg chg="del">
        <pc:chgData name="Waters, Christopher" userId="62418469-15cb-4bfd-8077-e64d9edbe607" providerId="ADAL" clId="{D0E6B1A4-B86E-48C4-BA7A-F770D28330C7}" dt="2020-10-06T14:50:13.429" v="4" actId="47"/>
        <pc:sldMkLst>
          <pc:docMk/>
          <pc:sldMk cId="2721653835" sldId="268"/>
        </pc:sldMkLst>
      </pc:sldChg>
      <pc:sldChg chg="del">
        <pc:chgData name="Waters, Christopher" userId="62418469-15cb-4bfd-8077-e64d9edbe607" providerId="ADAL" clId="{D0E6B1A4-B86E-48C4-BA7A-F770D28330C7}" dt="2020-10-06T14:50:13.047" v="3" actId="47"/>
        <pc:sldMkLst>
          <pc:docMk/>
          <pc:sldMk cId="1523904752" sldId="271"/>
        </pc:sldMkLst>
      </pc:sldChg>
      <pc:sldChg chg="del">
        <pc:chgData name="Waters, Christopher" userId="62418469-15cb-4bfd-8077-e64d9edbe607" providerId="ADAL" clId="{D0E6B1A4-B86E-48C4-BA7A-F770D28330C7}" dt="2020-10-06T14:50:09.669" v="0" actId="47"/>
        <pc:sldMkLst>
          <pc:docMk/>
          <pc:sldMk cId="4023863908" sldId="274"/>
        </pc:sldMkLst>
      </pc:sldChg>
      <pc:sldChg chg="del">
        <pc:chgData name="Waters, Christopher" userId="62418469-15cb-4bfd-8077-e64d9edbe607" providerId="ADAL" clId="{D0E6B1A4-B86E-48C4-BA7A-F770D28330C7}" dt="2020-10-06T14:50:10.930" v="2" actId="47"/>
        <pc:sldMkLst>
          <pc:docMk/>
          <pc:sldMk cId="2661597603" sldId="278"/>
        </pc:sldMkLst>
      </pc:sldChg>
      <pc:sldChg chg="del">
        <pc:chgData name="Waters, Christopher" userId="62418469-15cb-4bfd-8077-e64d9edbe607" providerId="ADAL" clId="{D0E6B1A4-B86E-48C4-BA7A-F770D28330C7}" dt="2020-10-06T14:50:14.283" v="6" actId="47"/>
        <pc:sldMkLst>
          <pc:docMk/>
          <pc:sldMk cId="3940385423" sldId="314"/>
        </pc:sldMkLst>
      </pc:sldChg>
      <pc:sldChg chg="del">
        <pc:chgData name="Waters, Christopher" userId="62418469-15cb-4bfd-8077-e64d9edbe607" providerId="ADAL" clId="{D0E6B1A4-B86E-48C4-BA7A-F770D28330C7}" dt="2020-10-06T14:50:13.820" v="5" actId="47"/>
        <pc:sldMkLst>
          <pc:docMk/>
          <pc:sldMk cId="200701545" sldId="316"/>
        </pc:sldMkLst>
      </pc:sldChg>
      <pc:sldChg chg="del">
        <pc:chgData name="Waters, Christopher" userId="62418469-15cb-4bfd-8077-e64d9edbe607" providerId="ADAL" clId="{D0E6B1A4-B86E-48C4-BA7A-F770D28330C7}" dt="2020-10-06T14:50:15.252" v="8" actId="47"/>
        <pc:sldMkLst>
          <pc:docMk/>
          <pc:sldMk cId="3697134398" sldId="320"/>
        </pc:sldMkLst>
      </pc:sldChg>
      <pc:sldChg chg="del">
        <pc:chgData name="Waters, Christopher" userId="62418469-15cb-4bfd-8077-e64d9edbe607" providerId="ADAL" clId="{D0E6B1A4-B86E-48C4-BA7A-F770D28330C7}" dt="2020-10-06T14:50:10.314" v="1" actId="47"/>
        <pc:sldMkLst>
          <pc:docMk/>
          <pc:sldMk cId="1186078525" sldId="322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659830-ED58-824D-9109-DC876CA9D4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37C91B-74FD-C346-BDAE-87F7850D56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00C38A-A642-F24A-99D9-AB5701CE3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B19F02-A694-3F47-BB15-90635F330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956B6D-7046-7847-8768-70E51ADFD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135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B6F415-AA81-EE46-9570-2B07B39509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0B9750-321C-1241-B7D3-7E7D4885C4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6538BE-95B7-874F-B826-FA8982FE3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B05F8-2C54-5445-94E2-5CC7054D8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7B0826-2E1F-AA47-BF02-CC169E000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063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76CCE1-B819-2447-894E-F5E7D50569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4924AF-7A68-CC42-AF62-91A3FFFA27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05309F-C7FF-E141-8907-2A9E876DF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93C382-ABB6-3E41-BF15-60DD77554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DC47CF-5664-964E-B7AE-5DF772472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3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D328FD-B344-6D45-9E6B-58D8F0098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F21223-223A-4947-AEE8-EFB59A3946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5EC0A4-4A62-6045-BF7A-87D56A2100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A07320-0E8C-C845-BE63-799A9C6CD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574C76-B280-D940-8A81-F24BFE2D71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317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E7B8C8-4381-4E4D-B2A5-3E40C187D0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A1A0C9-84BE-B14C-A2A6-4E29AD2354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10993C-8B45-C94E-9886-304BCA387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2B82EB-2E72-0F4E-8CCB-A4AE3C0C6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35B4D5-4317-4B41-B4E6-90BDBBBF98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540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8E438D-A2B7-364F-A82D-9551F435A1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CBC450-5751-0E45-8BD5-87C9594C4E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274DAD-F8D3-8744-B5A2-FAA227CDCD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2C7D8D-75AE-A64A-BC82-10D1AA3EE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4DABFC-F9F3-0242-8984-4D3130C3EE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3A1453-0DBF-774F-86A7-2F3C83B1B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614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8C7AC8-2C6D-364A-844D-8CC38E1CD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9D3A33-5920-F941-9974-2684729885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8F2CE7-C798-584B-B9DE-67235E7A04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9450E5-ADF8-8642-9F0B-CC2C679932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E74728-10D0-2244-AC13-B23325FC7B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D44FA7-207E-1C48-B266-54289530C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14F2B4-08FB-8D4B-A2BA-820D0E3BD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A996D7-7DEE-B749-B1AE-FC8A1CE88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010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D0B843-10A2-E549-8B49-88BAF81F45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64447E-DA97-AF44-938B-80CC64AD9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30D34F2-1F36-2449-9BA0-4950F7F89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F43699-E8BB-F742-A9E6-11704511E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581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930F095-D827-0F40-AC34-B8EBC6999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A9818E-C21D-3E49-8794-24615DD7D3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723274-E0F0-8044-A30E-37489EB32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11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37ED2B-B588-F542-B327-FF6FA888EB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87E501-EB11-2843-A2D5-90DF257448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3D69D2-26CB-974C-A837-5CEE017D36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F43738-4D89-DD47-B523-8FDA04C2C4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9C1A8E-27EB-4741-B9AF-10FBBA557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BD9C3A-C2D7-424F-9ABA-5AFFC01DE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599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E104C6-6CCA-A740-80C7-57714D2505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ACE8D9-E09C-7449-9C65-A2E5D4AA72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5B7302-2E67-A949-85C1-CFCD609997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AC8B09-E20E-764B-8159-D4C03580D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B9739A-3F6F-E84C-A4A7-6876E2456E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B7B9D2-AAE2-5840-B433-F7F35B2C8F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26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54170AA-1612-BD45-9A0A-015965E9D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FB8510-C26C-B84A-8B06-5D242E0E84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ABD935-A200-2D44-958B-DC444F57FE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906807-A097-6A4D-A8D9-CFE1236614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1A3A0E-EA09-FE4B-8A12-89ABAFD045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41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screenshot of a cell phone&#10;&#10;Description automatically generated">
            <a:extLst>
              <a:ext uri="{FF2B5EF4-FFF2-40B4-BE49-F238E27FC236}">
                <a16:creationId xmlns:a16="http://schemas.microsoft.com/office/drawing/2014/main" id="{44F6B78C-23C0-8A4A-BFCD-6CE79224EB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43808" y="28460"/>
            <a:ext cx="4437717" cy="3864668"/>
          </a:xfrm>
          <a:prstGeom prst="rect">
            <a:avLst/>
          </a:prstGeom>
        </p:spPr>
      </p:pic>
      <p:pic>
        <p:nvPicPr>
          <p:cNvPr id="3" name="Picture 2" descr="A close up of a logo&#10;&#10;Description automatically generated">
            <a:extLst>
              <a:ext uri="{FF2B5EF4-FFF2-40B4-BE49-F238E27FC236}">
                <a16:creationId xmlns:a16="http://schemas.microsoft.com/office/drawing/2014/main" id="{68E8B989-B7F7-4647-81EA-B4967CF977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0370" y="217865"/>
            <a:ext cx="3155002" cy="3686814"/>
          </a:xfrm>
          <a:prstGeom prst="rect">
            <a:avLst/>
          </a:prstGeom>
        </p:spPr>
      </p:pic>
      <p:sp>
        <p:nvSpPr>
          <p:cNvPr id="90" name="Rectangle 89">
            <a:extLst>
              <a:ext uri="{FF2B5EF4-FFF2-40B4-BE49-F238E27FC236}">
                <a16:creationId xmlns:a16="http://schemas.microsoft.com/office/drawing/2014/main" id="{2AC9718F-B5FC-6640-8674-353C2C329B1D}"/>
              </a:ext>
            </a:extLst>
          </p:cNvPr>
          <p:cNvSpPr/>
          <p:nvPr/>
        </p:nvSpPr>
        <p:spPr>
          <a:xfrm rot="16200000">
            <a:off x="3927980" y="2025409"/>
            <a:ext cx="1175737" cy="3041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634EF87-E84E-EF4F-B437-40990C8A0F0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851"/>
          <a:stretch/>
        </p:blipFill>
        <p:spPr>
          <a:xfrm>
            <a:off x="135556" y="64564"/>
            <a:ext cx="3804658" cy="382856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44B0DB7-C5FB-B043-A86C-06EADEFBAEC6}"/>
              </a:ext>
            </a:extLst>
          </p:cNvPr>
          <p:cNvSpPr txBox="1"/>
          <p:nvPr/>
        </p:nvSpPr>
        <p:spPr>
          <a:xfrm>
            <a:off x="41009" y="-27710"/>
            <a:ext cx="2474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BFAFF37-3F22-FB4E-92D3-4DE8A161F6C2}"/>
              </a:ext>
            </a:extLst>
          </p:cNvPr>
          <p:cNvSpPr txBox="1"/>
          <p:nvPr/>
        </p:nvSpPr>
        <p:spPr>
          <a:xfrm>
            <a:off x="3956633" y="-36063"/>
            <a:ext cx="2474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3A2B19E-FEAF-5B4E-BC62-1C7FA7FF9951}"/>
              </a:ext>
            </a:extLst>
          </p:cNvPr>
          <p:cNvSpPr txBox="1"/>
          <p:nvPr/>
        </p:nvSpPr>
        <p:spPr>
          <a:xfrm>
            <a:off x="7623413" y="-7658"/>
            <a:ext cx="2474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cs typeface="Arial" panose="020B0604020202020204" pitchFamily="34" charset="0"/>
              </a:rPr>
              <a:t>C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3EF05EE-74EA-8249-88D2-595CF8087483}"/>
              </a:ext>
            </a:extLst>
          </p:cNvPr>
          <p:cNvSpPr/>
          <p:nvPr/>
        </p:nvSpPr>
        <p:spPr>
          <a:xfrm>
            <a:off x="4675656" y="90266"/>
            <a:ext cx="2759766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F6D63B2-34B6-B74A-9E74-D932F2CE11D0}"/>
              </a:ext>
            </a:extLst>
          </p:cNvPr>
          <p:cNvSpPr/>
          <p:nvPr/>
        </p:nvSpPr>
        <p:spPr>
          <a:xfrm>
            <a:off x="738743" y="91543"/>
            <a:ext cx="2759766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ED2C1746-BEA4-A945-B3B1-371890476A8F}"/>
              </a:ext>
            </a:extLst>
          </p:cNvPr>
          <p:cNvSpPr/>
          <p:nvPr/>
        </p:nvSpPr>
        <p:spPr>
          <a:xfrm>
            <a:off x="8724653" y="217865"/>
            <a:ext cx="2759766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7640250-F4C6-2848-A066-758FB62C22A6}"/>
              </a:ext>
            </a:extLst>
          </p:cNvPr>
          <p:cNvSpPr txBox="1"/>
          <p:nvPr/>
        </p:nvSpPr>
        <p:spPr>
          <a:xfrm>
            <a:off x="9887464" y="3772722"/>
            <a:ext cx="15378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TC-A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B343D6AB-171E-F849-9036-93AFB358BB7A}"/>
              </a:ext>
            </a:extLst>
          </p:cNvPr>
          <p:cNvSpPr/>
          <p:nvPr/>
        </p:nvSpPr>
        <p:spPr>
          <a:xfrm rot="16200000">
            <a:off x="-1083516" y="1996542"/>
            <a:ext cx="2759766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B4692105-A302-D045-B3B6-CC523D5530AB}"/>
              </a:ext>
            </a:extLst>
          </p:cNvPr>
          <p:cNvSpPr/>
          <p:nvPr/>
        </p:nvSpPr>
        <p:spPr>
          <a:xfrm rot="16200000">
            <a:off x="3030848" y="1929231"/>
            <a:ext cx="2759766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FB8E8198-0271-2E45-8AAE-FAFB047BC9ED}"/>
              </a:ext>
            </a:extLst>
          </p:cNvPr>
          <p:cNvSpPr/>
          <p:nvPr/>
        </p:nvSpPr>
        <p:spPr>
          <a:xfrm rot="16200000">
            <a:off x="6742019" y="1715955"/>
            <a:ext cx="2405119" cy="1758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4643BD7A-98F3-624A-A28C-CB33B0B15D68}"/>
              </a:ext>
            </a:extLst>
          </p:cNvPr>
          <p:cNvSpPr/>
          <p:nvPr/>
        </p:nvSpPr>
        <p:spPr>
          <a:xfrm>
            <a:off x="850318" y="3586141"/>
            <a:ext cx="2759766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9DCE53E-D6BF-1740-9C05-500F7F7DD9E3}"/>
              </a:ext>
            </a:extLst>
          </p:cNvPr>
          <p:cNvSpPr/>
          <p:nvPr/>
        </p:nvSpPr>
        <p:spPr>
          <a:xfrm>
            <a:off x="4609897" y="3740728"/>
            <a:ext cx="2759766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58989D7-600D-FF49-A8E2-F5291B0AD0F2}"/>
              </a:ext>
            </a:extLst>
          </p:cNvPr>
          <p:cNvSpPr txBox="1"/>
          <p:nvPr/>
        </p:nvSpPr>
        <p:spPr>
          <a:xfrm>
            <a:off x="5684671" y="3776076"/>
            <a:ext cx="15378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12F2BC29-1FBA-9E4C-B209-33DFD76B0C62}"/>
              </a:ext>
            </a:extLst>
          </p:cNvPr>
          <p:cNvSpPr/>
          <p:nvPr/>
        </p:nvSpPr>
        <p:spPr>
          <a:xfrm>
            <a:off x="8724653" y="3436748"/>
            <a:ext cx="2759766" cy="3453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D0343D5-0263-EA45-B0E2-1528F0E2DF15}"/>
              </a:ext>
            </a:extLst>
          </p:cNvPr>
          <p:cNvSpPr txBox="1"/>
          <p:nvPr/>
        </p:nvSpPr>
        <p:spPr>
          <a:xfrm>
            <a:off x="1754906" y="1117637"/>
            <a:ext cx="9631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9332787-7403-B14F-9EDF-91D35CEF2249}"/>
              </a:ext>
            </a:extLst>
          </p:cNvPr>
          <p:cNvSpPr txBox="1"/>
          <p:nvPr/>
        </p:nvSpPr>
        <p:spPr>
          <a:xfrm>
            <a:off x="6235814" y="1791346"/>
            <a:ext cx="49365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97F2C3D-17DA-8D46-85DF-927BE12B414C}"/>
              </a:ext>
            </a:extLst>
          </p:cNvPr>
          <p:cNvSpPr txBox="1"/>
          <p:nvPr/>
        </p:nvSpPr>
        <p:spPr>
          <a:xfrm>
            <a:off x="9483300" y="947936"/>
            <a:ext cx="621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5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07780973-2716-1F47-AB33-F98ECF57F5F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76435" y="2365985"/>
            <a:ext cx="308693" cy="34290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3EBA70AC-6CE9-C244-851B-D63B1906621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04476" y="2453307"/>
            <a:ext cx="308693" cy="3429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C0B2EFCD-30B5-BC4A-9C19-AD63C86E3A9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24188" y="1434913"/>
            <a:ext cx="218611" cy="220328"/>
          </a:xfrm>
          <a:prstGeom prst="rect">
            <a:avLst/>
          </a:prstGeom>
        </p:spPr>
      </p:pic>
      <p:sp>
        <p:nvSpPr>
          <p:cNvPr id="47" name="Rectangle 46">
            <a:extLst>
              <a:ext uri="{FF2B5EF4-FFF2-40B4-BE49-F238E27FC236}">
                <a16:creationId xmlns:a16="http://schemas.microsoft.com/office/drawing/2014/main" id="{E0D14943-918A-6B4B-8C9C-C75EE26A5AD1}"/>
              </a:ext>
            </a:extLst>
          </p:cNvPr>
          <p:cNvSpPr/>
          <p:nvPr/>
        </p:nvSpPr>
        <p:spPr>
          <a:xfrm>
            <a:off x="9643062" y="2113010"/>
            <a:ext cx="1197588" cy="699640"/>
          </a:xfrm>
          <a:prstGeom prst="rect">
            <a:avLst/>
          </a:prstGeom>
          <a:noFill/>
          <a:ln w="349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FDA926F4-C634-A740-AF3B-BBFF6F90CEB8}"/>
              </a:ext>
            </a:extLst>
          </p:cNvPr>
          <p:cNvSpPr/>
          <p:nvPr/>
        </p:nvSpPr>
        <p:spPr>
          <a:xfrm>
            <a:off x="673569" y="262231"/>
            <a:ext cx="3194290" cy="308719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E4D67980-A397-C944-95CC-783B2F817F47}"/>
              </a:ext>
            </a:extLst>
          </p:cNvPr>
          <p:cNvSpPr/>
          <p:nvPr/>
        </p:nvSpPr>
        <p:spPr>
          <a:xfrm>
            <a:off x="4709539" y="262231"/>
            <a:ext cx="2589335" cy="321782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DA92B20A-0EFC-0845-A438-7E06EF1A78A5}"/>
              </a:ext>
            </a:extLst>
          </p:cNvPr>
          <p:cNvSpPr/>
          <p:nvPr/>
        </p:nvSpPr>
        <p:spPr>
          <a:xfrm>
            <a:off x="177208" y="390775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5</a:t>
            </a:r>
            <a:endParaRPr lang="en-US" sz="1200" b="1" dirty="0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7E48B102-5709-A34D-9CCB-FDF30ACCA72F}"/>
              </a:ext>
            </a:extLst>
          </p:cNvPr>
          <p:cNvSpPr/>
          <p:nvPr/>
        </p:nvSpPr>
        <p:spPr>
          <a:xfrm>
            <a:off x="174062" y="979137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4</a:t>
            </a:r>
            <a:endParaRPr lang="en-US" sz="1200" b="1" dirty="0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7114724E-675A-F141-878E-CF5E43956EF8}"/>
              </a:ext>
            </a:extLst>
          </p:cNvPr>
          <p:cNvSpPr/>
          <p:nvPr/>
        </p:nvSpPr>
        <p:spPr>
          <a:xfrm>
            <a:off x="173828" y="2244568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2</a:t>
            </a:r>
            <a:endParaRPr lang="en-US" sz="1200" b="1" dirty="0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908BC81B-F190-984F-9DBD-B865F4F1F0BA}"/>
              </a:ext>
            </a:extLst>
          </p:cNvPr>
          <p:cNvSpPr/>
          <p:nvPr/>
        </p:nvSpPr>
        <p:spPr>
          <a:xfrm>
            <a:off x="173828" y="2848596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1</a:t>
            </a:r>
            <a:endParaRPr lang="en-US" sz="1200" b="1" dirty="0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67DC3A34-FB59-3348-A934-518A91D78173}"/>
              </a:ext>
            </a:extLst>
          </p:cNvPr>
          <p:cNvSpPr/>
          <p:nvPr/>
        </p:nvSpPr>
        <p:spPr>
          <a:xfrm>
            <a:off x="172598" y="1655710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3</a:t>
            </a:r>
            <a:endParaRPr lang="en-US" sz="12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988C277-338E-8244-AE67-3AB71AB07616}"/>
              </a:ext>
            </a:extLst>
          </p:cNvPr>
          <p:cNvSpPr txBox="1"/>
          <p:nvPr/>
        </p:nvSpPr>
        <p:spPr>
          <a:xfrm rot="16200000">
            <a:off x="-648135" y="1364489"/>
            <a:ext cx="1537854" cy="338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0EFE1F8B-9F14-C843-8B18-32FDDA9F0317}"/>
              </a:ext>
            </a:extLst>
          </p:cNvPr>
          <p:cNvSpPr/>
          <p:nvPr/>
        </p:nvSpPr>
        <p:spPr>
          <a:xfrm>
            <a:off x="863345" y="3447641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1</a:t>
            </a:r>
            <a:endParaRPr lang="en-US" sz="1200" b="1" dirty="0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82F71D7B-8A39-5740-9343-2BA72B7696C7}"/>
              </a:ext>
            </a:extLst>
          </p:cNvPr>
          <p:cNvSpPr/>
          <p:nvPr/>
        </p:nvSpPr>
        <p:spPr>
          <a:xfrm>
            <a:off x="1473639" y="3436748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2</a:t>
            </a:r>
            <a:endParaRPr lang="en-US" sz="1200" b="1" dirty="0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86F37878-D950-404A-B497-EC2A39845432}"/>
              </a:ext>
            </a:extLst>
          </p:cNvPr>
          <p:cNvSpPr/>
          <p:nvPr/>
        </p:nvSpPr>
        <p:spPr>
          <a:xfrm>
            <a:off x="2187840" y="3440603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3</a:t>
            </a:r>
            <a:endParaRPr lang="en-US" sz="1200" b="1" dirty="0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45947348-1C66-E946-89F7-33376E26A783}"/>
              </a:ext>
            </a:extLst>
          </p:cNvPr>
          <p:cNvSpPr/>
          <p:nvPr/>
        </p:nvSpPr>
        <p:spPr>
          <a:xfrm>
            <a:off x="2757440" y="3456994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4</a:t>
            </a:r>
            <a:endParaRPr lang="en-US" sz="1200" b="1" dirty="0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8A7D16AB-FA7B-624B-ACD0-78AA00F54870}"/>
              </a:ext>
            </a:extLst>
          </p:cNvPr>
          <p:cNvSpPr/>
          <p:nvPr/>
        </p:nvSpPr>
        <p:spPr>
          <a:xfrm>
            <a:off x="3421038" y="3445634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5</a:t>
            </a:r>
            <a:endParaRPr lang="en-US" sz="1200" b="1" dirty="0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6B153792-62E1-474F-9280-11474FC130FF}"/>
              </a:ext>
            </a:extLst>
          </p:cNvPr>
          <p:cNvSpPr/>
          <p:nvPr/>
        </p:nvSpPr>
        <p:spPr>
          <a:xfrm>
            <a:off x="4824049" y="3544600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1</a:t>
            </a:r>
            <a:endParaRPr lang="en-US" sz="1200" b="1" dirty="0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942F5242-E186-154F-A73B-AFF381D29831}"/>
              </a:ext>
            </a:extLst>
          </p:cNvPr>
          <p:cNvSpPr/>
          <p:nvPr/>
        </p:nvSpPr>
        <p:spPr>
          <a:xfrm>
            <a:off x="5365481" y="3544599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2</a:t>
            </a:r>
            <a:endParaRPr lang="en-US" sz="1200" b="1" dirty="0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2D1CE591-860F-6745-AE29-8B94E083384A}"/>
              </a:ext>
            </a:extLst>
          </p:cNvPr>
          <p:cNvSpPr/>
          <p:nvPr/>
        </p:nvSpPr>
        <p:spPr>
          <a:xfrm>
            <a:off x="5827171" y="3545096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3</a:t>
            </a:r>
            <a:endParaRPr lang="en-US" sz="1200" b="1" dirty="0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CD8AF8F4-7F3C-9844-ADB4-DC8C0FE9DEF3}"/>
              </a:ext>
            </a:extLst>
          </p:cNvPr>
          <p:cNvSpPr/>
          <p:nvPr/>
        </p:nvSpPr>
        <p:spPr>
          <a:xfrm>
            <a:off x="6421581" y="3562887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4</a:t>
            </a:r>
            <a:endParaRPr lang="en-US" sz="1200" b="1" dirty="0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B4BCE1D8-ADF1-9E45-93E4-1B6A5860DC3A}"/>
              </a:ext>
            </a:extLst>
          </p:cNvPr>
          <p:cNvSpPr/>
          <p:nvPr/>
        </p:nvSpPr>
        <p:spPr>
          <a:xfrm>
            <a:off x="6943281" y="3551674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5</a:t>
            </a:r>
            <a:endParaRPr lang="en-US" sz="1200" b="1" dirty="0"/>
          </a:p>
        </p:txBody>
      </p:sp>
      <p:pic>
        <p:nvPicPr>
          <p:cNvPr id="70" name="Picture 69">
            <a:extLst>
              <a:ext uri="{FF2B5EF4-FFF2-40B4-BE49-F238E27FC236}">
                <a16:creationId xmlns:a16="http://schemas.microsoft.com/office/drawing/2014/main" id="{1482C212-283B-AA48-9BD2-6514E6D25DD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8825" y="3374731"/>
            <a:ext cx="313698" cy="132828"/>
          </a:xfrm>
          <a:prstGeom prst="rect">
            <a:avLst/>
          </a:prstGeom>
        </p:spPr>
      </p:pic>
      <p:sp>
        <p:nvSpPr>
          <p:cNvPr id="71" name="Rectangle 70">
            <a:extLst>
              <a:ext uri="{FF2B5EF4-FFF2-40B4-BE49-F238E27FC236}">
                <a16:creationId xmlns:a16="http://schemas.microsoft.com/office/drawing/2014/main" id="{71B5A9E0-ADDC-D744-ABB9-847D2B92BBC0}"/>
              </a:ext>
            </a:extLst>
          </p:cNvPr>
          <p:cNvSpPr/>
          <p:nvPr/>
        </p:nvSpPr>
        <p:spPr>
          <a:xfrm>
            <a:off x="9250939" y="3436748"/>
            <a:ext cx="3907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0</a:t>
            </a: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F51997D2-4022-384F-B4F5-987EB80E424A}"/>
              </a:ext>
            </a:extLst>
          </p:cNvPr>
          <p:cNvSpPr/>
          <p:nvPr/>
        </p:nvSpPr>
        <p:spPr>
          <a:xfrm>
            <a:off x="7843441" y="2499260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2</a:t>
            </a:r>
            <a:endParaRPr lang="en-US" sz="1200" b="1" dirty="0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BA614C0D-2EAF-B345-A1C4-D860E772AC2B}"/>
              </a:ext>
            </a:extLst>
          </p:cNvPr>
          <p:cNvSpPr/>
          <p:nvPr/>
        </p:nvSpPr>
        <p:spPr>
          <a:xfrm>
            <a:off x="9456103" y="3450340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3</a:t>
            </a:r>
            <a:endParaRPr lang="en-US" sz="1200" b="1" dirty="0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F9B26586-C722-D140-990D-FA2537040B98}"/>
              </a:ext>
            </a:extLst>
          </p:cNvPr>
          <p:cNvSpPr/>
          <p:nvPr/>
        </p:nvSpPr>
        <p:spPr>
          <a:xfrm>
            <a:off x="10478970" y="3451777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4</a:t>
            </a:r>
            <a:endParaRPr lang="en-US" sz="1200" b="1" dirty="0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52DBB883-6C66-9C43-BD5B-ED83B007CBA1}"/>
              </a:ext>
            </a:extLst>
          </p:cNvPr>
          <p:cNvSpPr/>
          <p:nvPr/>
        </p:nvSpPr>
        <p:spPr>
          <a:xfrm>
            <a:off x="11313169" y="3425742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5</a:t>
            </a:r>
            <a:endParaRPr lang="en-US" sz="1200" b="1" dirty="0"/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E146A308-BD1D-2A4A-B7F3-ACBE179686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4878" y="3511468"/>
            <a:ext cx="514555" cy="217876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BF657FED-7A96-A348-B47D-5A49BDAF552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82880" y="3204250"/>
            <a:ext cx="514555" cy="275807"/>
          </a:xfrm>
          <a:prstGeom prst="rect">
            <a:avLst/>
          </a:prstGeom>
        </p:spPr>
      </p:pic>
      <p:sp>
        <p:nvSpPr>
          <p:cNvPr id="78" name="Rectangle 77">
            <a:extLst>
              <a:ext uri="{FF2B5EF4-FFF2-40B4-BE49-F238E27FC236}">
                <a16:creationId xmlns:a16="http://schemas.microsoft.com/office/drawing/2014/main" id="{C0B9273F-756D-454C-80C9-AE8A9EE3C686}"/>
              </a:ext>
            </a:extLst>
          </p:cNvPr>
          <p:cNvSpPr/>
          <p:nvPr/>
        </p:nvSpPr>
        <p:spPr>
          <a:xfrm>
            <a:off x="7852585" y="1934242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3</a:t>
            </a:r>
            <a:endParaRPr lang="en-US" sz="1200" b="1" dirty="0"/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7D1CE359-AE8D-8246-9D1C-393336A9CC48}"/>
              </a:ext>
            </a:extLst>
          </p:cNvPr>
          <p:cNvSpPr/>
          <p:nvPr/>
        </p:nvSpPr>
        <p:spPr>
          <a:xfrm>
            <a:off x="7852585" y="1213597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4</a:t>
            </a:r>
            <a:endParaRPr lang="en-US" sz="1200" b="1" dirty="0"/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6F696A60-43B6-2D45-A129-DE1692533B19}"/>
              </a:ext>
            </a:extLst>
          </p:cNvPr>
          <p:cNvSpPr/>
          <p:nvPr/>
        </p:nvSpPr>
        <p:spPr>
          <a:xfrm>
            <a:off x="7871040" y="558077"/>
            <a:ext cx="39071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10</a:t>
            </a:r>
            <a:r>
              <a:rPr lang="en-US" sz="1200" b="1" baseline="30000" dirty="0"/>
              <a:t>5</a:t>
            </a:r>
            <a:endParaRPr lang="en-US" sz="1200" b="1" dirty="0"/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BB6E3D31-9B75-0640-AC89-55637202FB6B}"/>
              </a:ext>
            </a:extLst>
          </p:cNvPr>
          <p:cNvSpPr/>
          <p:nvPr/>
        </p:nvSpPr>
        <p:spPr>
          <a:xfrm>
            <a:off x="7940158" y="2691284"/>
            <a:ext cx="302421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0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B99886F1-1615-D748-8781-58C8D0C8B1AB}"/>
              </a:ext>
            </a:extLst>
          </p:cNvPr>
          <p:cNvSpPr/>
          <p:nvPr/>
        </p:nvSpPr>
        <p:spPr>
          <a:xfrm rot="16200000">
            <a:off x="4020481" y="2740055"/>
            <a:ext cx="1101812" cy="1140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812BDA74-9B71-2846-929E-B60E1632ABF2}"/>
              </a:ext>
            </a:extLst>
          </p:cNvPr>
          <p:cNvSpPr/>
          <p:nvPr/>
        </p:nvSpPr>
        <p:spPr>
          <a:xfrm>
            <a:off x="4288959" y="2596534"/>
            <a:ext cx="362595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50</a:t>
            </a: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BBD11B5D-C160-DF45-88B4-D76912EE28F3}"/>
              </a:ext>
            </a:extLst>
          </p:cNvPr>
          <p:cNvSpPr/>
          <p:nvPr/>
        </p:nvSpPr>
        <p:spPr>
          <a:xfrm>
            <a:off x="4294696" y="3348434"/>
            <a:ext cx="362595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0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359A03B3-FC66-1946-8010-636FD4DD0559}"/>
              </a:ext>
            </a:extLst>
          </p:cNvPr>
          <p:cNvSpPr/>
          <p:nvPr/>
        </p:nvSpPr>
        <p:spPr>
          <a:xfrm rot="16200000">
            <a:off x="3977704" y="907030"/>
            <a:ext cx="1175737" cy="1607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430DCB47-0BE0-4447-B933-642115FF46EB}"/>
              </a:ext>
            </a:extLst>
          </p:cNvPr>
          <p:cNvCxnSpPr>
            <a:cxnSpLocks/>
          </p:cNvCxnSpPr>
          <p:nvPr/>
        </p:nvCxnSpPr>
        <p:spPr>
          <a:xfrm flipH="1">
            <a:off x="4641075" y="263575"/>
            <a:ext cx="9683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Rectangle 82">
            <a:extLst>
              <a:ext uri="{FF2B5EF4-FFF2-40B4-BE49-F238E27FC236}">
                <a16:creationId xmlns:a16="http://schemas.microsoft.com/office/drawing/2014/main" id="{B2B1D6FC-6239-5C49-A35B-C40B4BA46DBA}"/>
              </a:ext>
            </a:extLst>
          </p:cNvPr>
          <p:cNvSpPr/>
          <p:nvPr/>
        </p:nvSpPr>
        <p:spPr>
          <a:xfrm>
            <a:off x="4252951" y="470695"/>
            <a:ext cx="48047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2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1EB274F-62A9-854C-BF67-A9ADA85D95DC}"/>
              </a:ext>
            </a:extLst>
          </p:cNvPr>
          <p:cNvSpPr txBox="1"/>
          <p:nvPr/>
        </p:nvSpPr>
        <p:spPr>
          <a:xfrm rot="16200000">
            <a:off x="3425592" y="1415334"/>
            <a:ext cx="15378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FF68486-97ED-E945-8AAC-C1855AEDE843}"/>
              </a:ext>
            </a:extLst>
          </p:cNvPr>
          <p:cNvSpPr txBox="1"/>
          <p:nvPr/>
        </p:nvSpPr>
        <p:spPr>
          <a:xfrm rot="16200000">
            <a:off x="6939705" y="1317692"/>
            <a:ext cx="15378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E-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EC2B579-31FE-A04C-913B-B3FF574AF17B}"/>
              </a:ext>
            </a:extLst>
          </p:cNvPr>
          <p:cNvSpPr txBox="1"/>
          <p:nvPr/>
        </p:nvSpPr>
        <p:spPr>
          <a:xfrm>
            <a:off x="1521846" y="3789095"/>
            <a:ext cx="15378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111CA122-C9B6-DB47-9D47-89FA425F58F8}"/>
              </a:ext>
            </a:extLst>
          </p:cNvPr>
          <p:cNvSpPr txBox="1"/>
          <p:nvPr/>
        </p:nvSpPr>
        <p:spPr>
          <a:xfrm>
            <a:off x="8963222" y="491012"/>
            <a:ext cx="16546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igher Membrane Potential 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8E01F793-2B0E-6E41-83C5-60888FF22381}"/>
              </a:ext>
            </a:extLst>
          </p:cNvPr>
          <p:cNvSpPr txBox="1"/>
          <p:nvPr/>
        </p:nvSpPr>
        <p:spPr>
          <a:xfrm>
            <a:off x="6022530" y="1139692"/>
            <a:ext cx="12223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ermeabilized </a:t>
            </a:r>
          </a:p>
        </p:txBody>
      </p: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B8A5C941-B1A9-E542-B5B5-D07A154C9AF6}"/>
              </a:ext>
            </a:extLst>
          </p:cNvPr>
          <p:cNvCxnSpPr>
            <a:cxnSpLocks/>
          </p:cNvCxnSpPr>
          <p:nvPr/>
        </p:nvCxnSpPr>
        <p:spPr>
          <a:xfrm flipH="1">
            <a:off x="6491323" y="1399507"/>
            <a:ext cx="283089" cy="36572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27E6D349-2E30-4F40-9E86-033B461735BA}"/>
              </a:ext>
            </a:extLst>
          </p:cNvPr>
          <p:cNvCxnSpPr/>
          <p:nvPr/>
        </p:nvCxnSpPr>
        <p:spPr>
          <a:xfrm>
            <a:off x="9862991" y="807110"/>
            <a:ext cx="388892" cy="37782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2717B88D-C46F-9C4E-BE4E-511E60CB6CF7}"/>
              </a:ext>
            </a:extLst>
          </p:cNvPr>
          <p:cNvSpPr txBox="1"/>
          <p:nvPr/>
        </p:nvSpPr>
        <p:spPr>
          <a:xfrm>
            <a:off x="6096000" y="415746"/>
            <a:ext cx="958009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tact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uter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97B72A60-AE62-5543-A26D-4CDF366D6D38}"/>
              </a:ext>
            </a:extLst>
          </p:cNvPr>
          <p:cNvSpPr txBox="1"/>
          <p:nvPr/>
        </p:nvSpPr>
        <p:spPr>
          <a:xfrm>
            <a:off x="8304491" y="1733207"/>
            <a:ext cx="16546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ower Membrane Potential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6617B01-3B9F-7748-9B0F-02E6BF2B4775}"/>
              </a:ext>
            </a:extLst>
          </p:cNvPr>
          <p:cNvSpPr txBox="1"/>
          <p:nvPr/>
        </p:nvSpPr>
        <p:spPr>
          <a:xfrm>
            <a:off x="5176092" y="1689674"/>
            <a:ext cx="46265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2</a:t>
            </a:r>
          </a:p>
        </p:txBody>
      </p: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E39F968B-1FA4-3B4E-8DF1-1B8022302BF8}"/>
              </a:ext>
            </a:extLst>
          </p:cNvPr>
          <p:cNvCxnSpPr>
            <a:cxnSpLocks/>
          </p:cNvCxnSpPr>
          <p:nvPr/>
        </p:nvCxnSpPr>
        <p:spPr>
          <a:xfrm>
            <a:off x="9182583" y="1974701"/>
            <a:ext cx="733992" cy="28211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>
            <a:extLst>
              <a:ext uri="{FF2B5EF4-FFF2-40B4-BE49-F238E27FC236}">
                <a16:creationId xmlns:a16="http://schemas.microsoft.com/office/drawing/2014/main" id="{EF44F0C8-96A4-EB4C-8643-98E90558D7CF}"/>
              </a:ext>
            </a:extLst>
          </p:cNvPr>
          <p:cNvSpPr/>
          <p:nvPr/>
        </p:nvSpPr>
        <p:spPr>
          <a:xfrm>
            <a:off x="9474052" y="1300486"/>
            <a:ext cx="1549085" cy="482857"/>
          </a:xfrm>
          <a:prstGeom prst="rect">
            <a:avLst/>
          </a:prstGeom>
          <a:noFill/>
          <a:ln w="349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486E156E-6B55-CF4F-889C-5455FBC44EBF}"/>
              </a:ext>
            </a:extLst>
          </p:cNvPr>
          <p:cNvSpPr/>
          <p:nvPr/>
        </p:nvSpPr>
        <p:spPr>
          <a:xfrm>
            <a:off x="8338389" y="414211"/>
            <a:ext cx="3481197" cy="2935215"/>
          </a:xfrm>
          <a:prstGeom prst="rect">
            <a:avLst/>
          </a:prstGeom>
          <a:noFill/>
          <a:ln w="412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7D71243-03DF-694E-947C-F5169E34229A}"/>
              </a:ext>
            </a:extLst>
          </p:cNvPr>
          <p:cNvSpPr txBox="1"/>
          <p:nvPr/>
        </p:nvSpPr>
        <p:spPr>
          <a:xfrm>
            <a:off x="10855759" y="2336099"/>
            <a:ext cx="621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4</a:t>
            </a: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0B29BDA8-7DE8-B94C-81A3-2AAC948BF1FE}"/>
              </a:ext>
            </a:extLst>
          </p:cNvPr>
          <p:cNvSpPr/>
          <p:nvPr/>
        </p:nvSpPr>
        <p:spPr>
          <a:xfrm>
            <a:off x="4245284" y="1919653"/>
            <a:ext cx="48047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EDA2066B-C31A-6C42-8DCF-B4F10CC79D66}"/>
              </a:ext>
            </a:extLst>
          </p:cNvPr>
          <p:cNvCxnSpPr>
            <a:cxnSpLocks/>
          </p:cNvCxnSpPr>
          <p:nvPr/>
        </p:nvCxnSpPr>
        <p:spPr>
          <a:xfrm flipH="1">
            <a:off x="5477729" y="835076"/>
            <a:ext cx="644425" cy="73836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741486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4DAA46E096FC440AE51667620FC2471" ma:contentTypeVersion="8" ma:contentTypeDescription="Create a new document." ma:contentTypeScope="" ma:versionID="8184695aebda49fdb4c591f5f069ddef">
  <xsd:schema xmlns:xsd="http://www.w3.org/2001/XMLSchema" xmlns:xs="http://www.w3.org/2001/XMLSchema" xmlns:p="http://schemas.microsoft.com/office/2006/metadata/properties" xmlns:ns2="25a369bd-ffdf-4711-8592-06418a0244de" targetNamespace="http://schemas.microsoft.com/office/2006/metadata/properties" ma:root="true" ma:fieldsID="0db20352f684ff61f3cbc15d9e6d1594" ns2:_="">
    <xsd:import namespace="25a369bd-ffdf-4711-8592-06418a0244d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5a369bd-ffdf-4711-8592-06418a0244d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9E45E8F-CD10-4835-99E9-15FB333CDD6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D875236-79F3-4337-8915-E83C08C33ABB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44821F9D-F547-4577-A288-E24A2EADBFE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5a369bd-ffdf-4711-8592-06418a0244d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6056</TotalTime>
  <Words>52</Words>
  <Application>Microsoft Office PowerPoint</Application>
  <PresentationFormat>Widescreen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ch. Supplemental </dc:title>
  <dc:creator>Michael Maiden</dc:creator>
  <cp:lastModifiedBy>Waters, Christopher</cp:lastModifiedBy>
  <cp:revision>423</cp:revision>
  <dcterms:created xsi:type="dcterms:W3CDTF">2018-07-21T18:41:50Z</dcterms:created>
  <dcterms:modified xsi:type="dcterms:W3CDTF">2020-10-06T14:50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4DAA46E096FC440AE51667620FC2471</vt:lpwstr>
  </property>
</Properties>
</file>